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272" r:id="rId2"/>
    <p:sldId id="265" r:id="rId3"/>
    <p:sldId id="273" r:id="rId4"/>
    <p:sldId id="274" r:id="rId5"/>
    <p:sldId id="264" r:id="rId6"/>
    <p:sldId id="260" r:id="rId7"/>
    <p:sldId id="263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79017" autoAdjust="0"/>
  </p:normalViewPr>
  <p:slideViewPr>
    <p:cSldViewPr snapToGrid="0">
      <p:cViewPr varScale="1">
        <p:scale>
          <a:sx n="84" d="100"/>
          <a:sy n="84" d="100"/>
        </p:scale>
        <p:origin x="1548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DEED49D-37B6-49E8-9AFA-90AB0B271113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64374E1-AF9F-4E31-84F3-CBBF2382D7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232137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Supp Figure 1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6A2C135-661F-4D7B-8012-8EC251150680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974340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800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Supp Figure 2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6A2C135-661F-4D7B-8012-8EC251150680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332527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upp Figure 3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64374E1-AF9F-4E31-84F3-CBBF2382D74F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0177879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Supp Figure 4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64374E1-AF9F-4E31-84F3-CBBF2382D74F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8397084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800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Supp Figure 5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6A2C135-661F-4D7B-8012-8EC251150680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3875429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800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Supp Figure 6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6A2C135-661F-4D7B-8012-8EC251150680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4821344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800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Supp Figure 7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6A2C135-661F-4D7B-8012-8EC251150680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646274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47C5A1-AC45-D539-FEA9-A5DEA9B6976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2091ABE-FB0D-A049-8E37-2273E4384E3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9AF7FC2-CE5B-1310-24B7-CBF718B20D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72D9AD-2350-4CE9-9ED6-1AFBC19A6B44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7BFDFC1-E092-1A67-BD7A-3BD0479A88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22C9E69-CAB0-D22F-0E9C-8BD028422F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487AF6-DA48-49D4-A908-9A5CBCA6E2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34452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01FF56E-D471-3CCD-F0C1-A3E97734924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528068C-2593-71E4-03BB-42D3DD9184A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9A7A25B-C5A7-9A15-9CB8-A400B4B4C9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72D9AD-2350-4CE9-9ED6-1AFBC19A6B44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729B792-CC27-E3C5-1989-095EC0A981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385FD22-BABB-81F6-FA4F-18B47E6545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487AF6-DA48-49D4-A908-9A5CBCA6E2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1225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1CA3843-F7C9-5277-07B4-974098004DD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A929B08-1344-E2C3-836E-D1996693CDD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A9B589C-A58D-1D86-02CD-2C9F13FB08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72D9AD-2350-4CE9-9ED6-1AFBC19A6B44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56B0B02-E36C-DD79-6E50-7D4D405226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007DEA0-5AB3-4D51-07FC-186AF8ED37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487AF6-DA48-49D4-A908-9A5CBCA6E2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13541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2B6F68-EB00-DA79-A3D3-CC2DE4894C3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11BCA67-4D2A-FF4F-C9C9-83704302167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CEEF4A4-9023-8E69-C381-DF329E0BE2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72D9AD-2350-4CE9-9ED6-1AFBC19A6B44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16C1C99-A3D9-8C5B-A462-317C6FD9C4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0A74431-2A10-1724-8C82-B0135CDC10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487AF6-DA48-49D4-A908-9A5CBCA6E2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55642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D2F36C-CF87-2AD4-58D6-BB5C3166658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92B6D3A-D223-B9B3-D93D-753974B9D2D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A6B9A2E-9BF5-A60A-57E7-BBDAE55004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72D9AD-2350-4CE9-9ED6-1AFBC19A6B44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1B9234C-416A-1A4F-CDE6-EFD94F919A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B347C94-E7EF-FFC5-4F4B-75585B21D9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487AF6-DA48-49D4-A908-9A5CBCA6E2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21219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0187E1-192A-0E91-0C58-6FB090272D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10CE83F-E32D-DEE1-5F82-569BCA4A4C3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B5F4A0F-7F25-6551-20A9-857B670B099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BE25F55-ED7F-83B2-E10E-D5455E4696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72D9AD-2350-4CE9-9ED6-1AFBC19A6B44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663FD09-8274-82A8-B5D6-0CB84EFB99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CFAC5EA-3982-A2A7-46A8-8BD104DB92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487AF6-DA48-49D4-A908-9A5CBCA6E2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50126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F94D9A-7635-F982-8340-FE05F812BB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A0C1048-37DD-20A4-7A6C-8BD883EC6E8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0E1121B-B3EA-19D1-C5CC-891B4907036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ED2C374-E4AE-44CF-6ED9-2021BEA9276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2EE29DA-F9D5-B48A-4A82-9B085332FA9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5A2FF29-AE8E-7FEA-D7D4-7EC16A73A2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72D9AD-2350-4CE9-9ED6-1AFBC19A6B44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BCF2A34-7216-B5A6-DA4B-B307B83D94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7BD4269-374D-CDE2-293C-CC44BA7D6E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487AF6-DA48-49D4-A908-9A5CBCA6E2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32552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225420-799D-1C46-A3EE-506C9424627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6F35133-B21F-2E7A-4632-B4BE382C49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72D9AD-2350-4CE9-9ED6-1AFBC19A6B44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9D273A5-FD2B-C70A-4AB1-F4043BA9C5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D98B917-06CA-F6A3-7BFA-EDD4A854E5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487AF6-DA48-49D4-A908-9A5CBCA6E2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82865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5BE0E63-DB12-7255-B438-6BE05601FE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72D9AD-2350-4CE9-9ED6-1AFBC19A6B44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3E3B4AB-67B8-969C-1C77-3D3D944481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68A63D1-11A2-485E-B31D-C741766B28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487AF6-DA48-49D4-A908-9A5CBCA6E2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11857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E90C273-2F53-0CC3-AA61-DF1DF66571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09E3E94-5DB8-8110-1765-1D0B7633E91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AFD411F-6689-15A2-BA77-749C635FB02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A333661-F510-8CC2-9770-13738D2F07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72D9AD-2350-4CE9-9ED6-1AFBC19A6B44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B55EDD7-6F8A-56D1-3F02-7615D279F4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A0D5223-E4F9-8455-EB9A-5B2F0FE2C1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487AF6-DA48-49D4-A908-9A5CBCA6E2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67619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87B464-435C-122B-0558-07F9E3600C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CA77138-9228-BC7E-E9F5-AAE87B2BA6E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88250D2-9EF1-DE75-E026-E006F3CDD23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68C7954-9D16-128E-46C0-D239282081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72D9AD-2350-4CE9-9ED6-1AFBC19A6B44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FA32E53-1F9C-6D6A-B6B2-A48D6B4E25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28E57D2-E39F-CEB6-1190-A917D0823D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487AF6-DA48-49D4-A908-9A5CBCA6E2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31184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10AA96D-AB15-6582-0BAC-5DDD66F8C24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0FC5C33-C122-9989-0B4D-732D0FC0364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C3D735E-12D9-8EBB-9CC9-F11CF224FFF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672D9AD-2350-4CE9-9ED6-1AFBC19A6B44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99B74AE-66B5-70BE-FF59-DDF776BE8BB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2E7C0E1-62B7-DC89-84D5-26F557BAFD2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7487AF6-DA48-49D4-A908-9A5CBCA6E2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79492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graph of a diagram&#10;&#10;AI-generated content may be incorrect.">
            <a:extLst>
              <a:ext uri="{FF2B5EF4-FFF2-40B4-BE49-F238E27FC236}">
                <a16:creationId xmlns:a16="http://schemas.microsoft.com/office/drawing/2014/main" id="{E127FFAF-329F-798E-C2FD-0ABBF3878D2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17820" y="947888"/>
            <a:ext cx="9956359" cy="4962224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220099750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>
            <a:extLst>
              <a:ext uri="{FF2B5EF4-FFF2-40B4-BE49-F238E27FC236}">
                <a16:creationId xmlns:a16="http://schemas.microsoft.com/office/drawing/2014/main" id="{919DCEEC-3CD5-9F99-88B7-FF300F48A4B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61340" y="817974"/>
            <a:ext cx="9669319" cy="52220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98944335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F6737F6-BF5F-AE93-8A30-964AC97D459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3353B5BB-7D27-5661-1B4F-755B0B9123E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91552" y="1266540"/>
            <a:ext cx="10208895" cy="5469508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5C279A50-FDE0-4260-061B-209AD9B8B7FB}"/>
              </a:ext>
            </a:extLst>
          </p:cNvPr>
          <p:cNvSpPr txBox="1"/>
          <p:nvPr/>
        </p:nvSpPr>
        <p:spPr>
          <a:xfrm>
            <a:off x="228600" y="182880"/>
            <a:ext cx="825246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H9683-1 Male</a:t>
            </a:r>
          </a:p>
          <a:p>
            <a:r>
              <a:rPr lang="en-US" i="1" dirty="0"/>
              <a:t>de novo</a:t>
            </a:r>
            <a:r>
              <a:rPr lang="en-US" dirty="0"/>
              <a:t> deletion 15q.11-13, paternal origin</a:t>
            </a:r>
          </a:p>
          <a:p>
            <a:r>
              <a:rPr lang="en-US" dirty="0"/>
              <a:t>PWS (MIM#172270)</a:t>
            </a:r>
          </a:p>
        </p:txBody>
      </p:sp>
    </p:spTree>
    <p:extLst>
      <p:ext uri="{BB962C8B-B14F-4D97-AF65-F5344CB8AC3E}">
        <p14:creationId xmlns:p14="http://schemas.microsoft.com/office/powerpoint/2010/main" val="372571361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54121666-AB65-4499-1B01-149A18BB80A5}"/>
              </a:ext>
            </a:extLst>
          </p:cNvPr>
          <p:cNvSpPr txBox="1"/>
          <p:nvPr/>
        </p:nvSpPr>
        <p:spPr>
          <a:xfrm>
            <a:off x="228600" y="182880"/>
            <a:ext cx="825246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H10684-1 Female</a:t>
            </a:r>
          </a:p>
          <a:p>
            <a:r>
              <a:rPr lang="en-US" i="1" dirty="0"/>
              <a:t>de novo</a:t>
            </a:r>
            <a:r>
              <a:rPr lang="en-US" dirty="0"/>
              <a:t> deletion 15q.11-13, maternal origin</a:t>
            </a:r>
          </a:p>
          <a:p>
            <a:r>
              <a:rPr lang="en-US" dirty="0"/>
              <a:t>AS (MIM#105830)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92E7A609-E4B6-E38C-E129-BEBF1852578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83920" y="1106210"/>
            <a:ext cx="10424160" cy="560698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4177370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655493-2FE8-9E0C-01A8-573582D3645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6D05ADE-8826-AEDB-AFB2-40E12BEA3CC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1026" name="Picture 2">
            <a:extLst>
              <a:ext uri="{FF2B5EF4-FFF2-40B4-BE49-F238E27FC236}">
                <a16:creationId xmlns:a16="http://schemas.microsoft.com/office/drawing/2014/main" id="{EB7218A2-01D2-54B7-3854-5353EE5B198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2899" y="192881"/>
            <a:ext cx="11506201" cy="64722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29B15A1C-FDA8-73A8-562B-A5BE2844A88C}"/>
              </a:ext>
            </a:extLst>
          </p:cNvPr>
          <p:cNvSpPr/>
          <p:nvPr/>
        </p:nvSpPr>
        <p:spPr>
          <a:xfrm>
            <a:off x="445770" y="365125"/>
            <a:ext cx="6903720" cy="59499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8E5F68D9-FAE2-DAC1-9E78-D61D6F7ACE81}"/>
              </a:ext>
            </a:extLst>
          </p:cNvPr>
          <p:cNvSpPr txBox="1"/>
          <p:nvPr/>
        </p:nvSpPr>
        <p:spPr>
          <a:xfrm>
            <a:off x="560070" y="104576"/>
            <a:ext cx="842391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H13688-1 Female</a:t>
            </a:r>
          </a:p>
          <a:p>
            <a:r>
              <a:rPr lang="en-US" i="1" dirty="0"/>
              <a:t>de novo </a:t>
            </a:r>
            <a:r>
              <a:rPr lang="en-US" dirty="0"/>
              <a:t>heterozygous deletion chrX:64,159,000-64,243,000</a:t>
            </a:r>
          </a:p>
          <a:p>
            <a:r>
              <a:rPr lang="en-US" dirty="0"/>
              <a:t>Arthrogryposis</a:t>
            </a:r>
          </a:p>
        </p:txBody>
      </p:sp>
    </p:spTree>
    <p:extLst>
      <p:ext uri="{BB962C8B-B14F-4D97-AF65-F5344CB8AC3E}">
        <p14:creationId xmlns:p14="http://schemas.microsoft.com/office/powerpoint/2010/main" val="127415537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diagram of a dna&#10;&#10;AI-generated content may be incorrect.">
            <a:extLst>
              <a:ext uri="{FF2B5EF4-FFF2-40B4-BE49-F238E27FC236}">
                <a16:creationId xmlns:a16="http://schemas.microsoft.com/office/drawing/2014/main" id="{0E5D894E-6615-57BB-5B4C-385EAF0BA137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14545" y="626931"/>
            <a:ext cx="9962910" cy="5604137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65233031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-up of a graph&#10;&#10;AI-generated content may be incorrect.">
            <a:extLst>
              <a:ext uri="{FF2B5EF4-FFF2-40B4-BE49-F238E27FC236}">
                <a16:creationId xmlns:a16="http://schemas.microsoft.com/office/drawing/2014/main" id="{5B4D1C55-4EEA-AA7F-5ACF-FA7A55F4372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8984" y="3549034"/>
            <a:ext cx="7891807" cy="3156723"/>
          </a:xfrm>
          <a:prstGeom prst="rect">
            <a:avLst/>
          </a:prstGeom>
        </p:spPr>
      </p:pic>
      <p:pic>
        <p:nvPicPr>
          <p:cNvPr id="6" name="Picture 5" descr="A close-up of a computer screen&#10;&#10;AI-generated content may be incorrect.">
            <a:extLst>
              <a:ext uri="{FF2B5EF4-FFF2-40B4-BE49-F238E27FC236}">
                <a16:creationId xmlns:a16="http://schemas.microsoft.com/office/drawing/2014/main" id="{4E72E700-F04D-CAF1-F64F-865F7BE69A3B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8985" y="152243"/>
            <a:ext cx="7891806" cy="3156722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45EE17B2-AB41-F2CA-7186-CE5646869709}"/>
              </a:ext>
            </a:extLst>
          </p:cNvPr>
          <p:cNvSpPr txBox="1"/>
          <p:nvPr/>
        </p:nvSpPr>
        <p:spPr>
          <a:xfrm>
            <a:off x="339363" y="152243"/>
            <a:ext cx="3676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4895873-8C71-DDE3-9E75-137C246102DC}"/>
              </a:ext>
            </a:extLst>
          </p:cNvPr>
          <p:cNvSpPr txBox="1"/>
          <p:nvPr/>
        </p:nvSpPr>
        <p:spPr>
          <a:xfrm>
            <a:off x="339363" y="3433672"/>
            <a:ext cx="3676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grpSp>
        <p:nvGrpSpPr>
          <p:cNvPr id="28" name="Group 27">
            <a:extLst>
              <a:ext uri="{FF2B5EF4-FFF2-40B4-BE49-F238E27FC236}">
                <a16:creationId xmlns:a16="http://schemas.microsoft.com/office/drawing/2014/main" id="{3F4E9C89-F227-D624-D238-E133D7391C1C}"/>
              </a:ext>
            </a:extLst>
          </p:cNvPr>
          <p:cNvGrpSpPr/>
          <p:nvPr/>
        </p:nvGrpSpPr>
        <p:grpSpPr>
          <a:xfrm>
            <a:off x="8946822" y="249481"/>
            <a:ext cx="2039334" cy="1966323"/>
            <a:chOff x="9313681" y="309472"/>
            <a:chExt cx="2039334" cy="1966323"/>
          </a:xfrm>
        </p:grpSpPr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A0ED52F6-CE4B-98D0-E66E-66FDDA768669}"/>
                </a:ext>
              </a:extLst>
            </p:cNvPr>
            <p:cNvSpPr txBox="1"/>
            <p:nvPr/>
          </p:nvSpPr>
          <p:spPr>
            <a:xfrm>
              <a:off x="10463752" y="758618"/>
              <a:ext cx="889263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i="1" dirty="0"/>
                <a:t>CMT1A</a:t>
              </a:r>
            </a:p>
            <a:p>
              <a:r>
                <a:rPr lang="en-US" sz="1200" dirty="0"/>
                <a:t>Clinical diagnosis</a:t>
              </a:r>
            </a:p>
          </p:txBody>
        </p:sp>
        <p:grpSp>
          <p:nvGrpSpPr>
            <p:cNvPr id="26" name="Group 25">
              <a:extLst>
                <a:ext uri="{FF2B5EF4-FFF2-40B4-BE49-F238E27FC236}">
                  <a16:creationId xmlns:a16="http://schemas.microsoft.com/office/drawing/2014/main" id="{EBF54FF0-A8A1-91EA-8BA0-C4773861B2DF}"/>
                </a:ext>
              </a:extLst>
            </p:cNvPr>
            <p:cNvGrpSpPr/>
            <p:nvPr/>
          </p:nvGrpSpPr>
          <p:grpSpPr>
            <a:xfrm>
              <a:off x="9313681" y="309472"/>
              <a:ext cx="1862579" cy="1966323"/>
              <a:chOff x="9313681" y="309472"/>
              <a:chExt cx="1862579" cy="1966323"/>
            </a:xfrm>
          </p:grpSpPr>
          <p:sp>
            <p:nvSpPr>
              <p:cNvPr id="9" name="Rectangle 8">
                <a:extLst>
                  <a:ext uri="{FF2B5EF4-FFF2-40B4-BE49-F238E27FC236}">
                    <a16:creationId xmlns:a16="http://schemas.microsoft.com/office/drawing/2014/main" id="{62684B0F-7168-6EB0-25B5-C42E7FCDD57F}"/>
                  </a:ext>
                </a:extLst>
              </p:cNvPr>
              <p:cNvSpPr/>
              <p:nvPr/>
            </p:nvSpPr>
            <p:spPr>
              <a:xfrm>
                <a:off x="9394595" y="309472"/>
                <a:ext cx="443060" cy="443060"/>
              </a:xfrm>
              <a:prstGeom prst="rect">
                <a:avLst/>
              </a:prstGeom>
              <a:noFill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0" name="Oval 9">
                <a:extLst>
                  <a:ext uri="{FF2B5EF4-FFF2-40B4-BE49-F238E27FC236}">
                    <a16:creationId xmlns:a16="http://schemas.microsoft.com/office/drawing/2014/main" id="{DAB0CCA5-65B1-016F-E8F9-C9CA6880E4BA}"/>
                  </a:ext>
                </a:extLst>
              </p:cNvPr>
              <p:cNvSpPr/>
              <p:nvPr/>
            </p:nvSpPr>
            <p:spPr>
              <a:xfrm>
                <a:off x="10501459" y="312573"/>
                <a:ext cx="443060" cy="443060"/>
              </a:xfrm>
              <a:prstGeom prst="ellipse">
                <a:avLst/>
              </a:prstGeom>
            </p:spPr>
            <p:style>
              <a:lnRef idx="2">
                <a:schemeClr val="dk1">
                  <a:shade val="15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1" name="Oval 10">
                <a:extLst>
                  <a:ext uri="{FF2B5EF4-FFF2-40B4-BE49-F238E27FC236}">
                    <a16:creationId xmlns:a16="http://schemas.microsoft.com/office/drawing/2014/main" id="{0DA57725-F438-F7DE-F5CF-E64A61E1FC05}"/>
                  </a:ext>
                </a:extLst>
              </p:cNvPr>
              <p:cNvSpPr/>
              <p:nvPr/>
            </p:nvSpPr>
            <p:spPr>
              <a:xfrm>
                <a:off x="9982985" y="1112321"/>
                <a:ext cx="443060" cy="443060"/>
              </a:xfrm>
              <a:prstGeom prst="ellipse">
                <a:avLst/>
              </a:prstGeom>
            </p:spPr>
            <p:style>
              <a:lnRef idx="2">
                <a:schemeClr val="dk1">
                  <a:shade val="15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13" name="Straight Connector 12">
                <a:extLst>
                  <a:ext uri="{FF2B5EF4-FFF2-40B4-BE49-F238E27FC236}">
                    <a16:creationId xmlns:a16="http://schemas.microsoft.com/office/drawing/2014/main" id="{AD3E1AE5-7B43-3A50-91A3-034DB10EBCB8}"/>
                  </a:ext>
                </a:extLst>
              </p:cNvPr>
              <p:cNvCxnSpPr>
                <a:cxnSpLocks/>
                <a:stCxn id="9" idx="3"/>
                <a:endCxn id="10" idx="2"/>
              </p:cNvCxnSpPr>
              <p:nvPr/>
            </p:nvCxnSpPr>
            <p:spPr>
              <a:xfrm>
                <a:off x="9837655" y="531002"/>
                <a:ext cx="663804" cy="3101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6" name="Straight Connector 15">
                <a:extLst>
                  <a:ext uri="{FF2B5EF4-FFF2-40B4-BE49-F238E27FC236}">
                    <a16:creationId xmlns:a16="http://schemas.microsoft.com/office/drawing/2014/main" id="{7CEECC39-879D-A7CF-D9B7-55D98F3098A3}"/>
                  </a:ext>
                </a:extLst>
              </p:cNvPr>
              <p:cNvCxnSpPr>
                <a:cxnSpLocks/>
                <a:stCxn id="11" idx="0"/>
              </p:cNvCxnSpPr>
              <p:nvPr/>
            </p:nvCxnSpPr>
            <p:spPr>
              <a:xfrm flipV="1">
                <a:off x="10204515" y="531002"/>
                <a:ext cx="0" cy="581319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AAC34482-40EF-B70E-F19B-4F4D5CABD9B4}"/>
                  </a:ext>
                </a:extLst>
              </p:cNvPr>
              <p:cNvSpPr txBox="1"/>
              <p:nvPr/>
            </p:nvSpPr>
            <p:spPr>
              <a:xfrm>
                <a:off x="9313681" y="1629464"/>
                <a:ext cx="1862579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/>
                  <a:t>PMGRC-488-488</a:t>
                </a:r>
              </a:p>
              <a:p>
                <a:pPr algn="ctr"/>
                <a:r>
                  <a:rPr lang="en-US" sz="1200" i="1" dirty="0"/>
                  <a:t>CMT1A</a:t>
                </a:r>
              </a:p>
              <a:p>
                <a:pPr algn="ctr"/>
                <a:r>
                  <a:rPr lang="en-US" sz="1200" i="1" dirty="0"/>
                  <a:t>PMP22</a:t>
                </a:r>
                <a:r>
                  <a:rPr lang="en-US" sz="1200" dirty="0"/>
                  <a:t> duplication</a:t>
                </a:r>
              </a:p>
            </p:txBody>
          </p:sp>
        </p:grpSp>
      </p:grpSp>
      <p:grpSp>
        <p:nvGrpSpPr>
          <p:cNvPr id="27" name="Group 26">
            <a:extLst>
              <a:ext uri="{FF2B5EF4-FFF2-40B4-BE49-F238E27FC236}">
                <a16:creationId xmlns:a16="http://schemas.microsoft.com/office/drawing/2014/main" id="{E9706D3D-AB8D-6281-05BC-B4A76060B798}"/>
              </a:ext>
            </a:extLst>
          </p:cNvPr>
          <p:cNvGrpSpPr/>
          <p:nvPr/>
        </p:nvGrpSpPr>
        <p:grpSpPr>
          <a:xfrm>
            <a:off x="8946822" y="3623184"/>
            <a:ext cx="1781666" cy="2122495"/>
            <a:chOff x="9232769" y="3549034"/>
            <a:chExt cx="1781666" cy="2122495"/>
          </a:xfrm>
        </p:grpSpPr>
        <p:sp>
          <p:nvSpPr>
            <p:cNvPr id="20" name="Rectangle 19">
              <a:extLst>
                <a:ext uri="{FF2B5EF4-FFF2-40B4-BE49-F238E27FC236}">
                  <a16:creationId xmlns:a16="http://schemas.microsoft.com/office/drawing/2014/main" id="{A8017775-DB78-CB69-D9BB-479F1B683FF7}"/>
                </a:ext>
              </a:extLst>
            </p:cNvPr>
            <p:cNvSpPr/>
            <p:nvPr/>
          </p:nvSpPr>
          <p:spPr>
            <a:xfrm>
              <a:off x="9313682" y="3549034"/>
              <a:ext cx="443060" cy="443060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1" name="Oval 20">
              <a:extLst>
                <a:ext uri="{FF2B5EF4-FFF2-40B4-BE49-F238E27FC236}">
                  <a16:creationId xmlns:a16="http://schemas.microsoft.com/office/drawing/2014/main" id="{BA4F9895-BF35-DE04-C5FF-94CB15654920}"/>
                </a:ext>
              </a:extLst>
            </p:cNvPr>
            <p:cNvSpPr/>
            <p:nvPr/>
          </p:nvSpPr>
          <p:spPr>
            <a:xfrm>
              <a:off x="10420546" y="3552135"/>
              <a:ext cx="443060" cy="443060"/>
            </a:xfrm>
            <a:prstGeom prst="ellipse">
              <a:avLst/>
            </a:prstGeom>
            <a:noFill/>
          </p:spPr>
          <p:style>
            <a:lnRef idx="2">
              <a:schemeClr val="dk1">
                <a:shade val="15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2" name="Oval 21">
              <a:extLst>
                <a:ext uri="{FF2B5EF4-FFF2-40B4-BE49-F238E27FC236}">
                  <a16:creationId xmlns:a16="http://schemas.microsoft.com/office/drawing/2014/main" id="{6EB55230-D018-D032-DBC7-A65F1E8950DE}"/>
                </a:ext>
              </a:extLst>
            </p:cNvPr>
            <p:cNvSpPr/>
            <p:nvPr/>
          </p:nvSpPr>
          <p:spPr>
            <a:xfrm>
              <a:off x="9902072" y="4351883"/>
              <a:ext cx="443060" cy="443060"/>
            </a:xfrm>
            <a:prstGeom prst="ellipse">
              <a:avLst/>
            </a:prstGeom>
          </p:spPr>
          <p:style>
            <a:lnRef idx="2">
              <a:schemeClr val="dk1">
                <a:shade val="15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23" name="Straight Connector 22">
              <a:extLst>
                <a:ext uri="{FF2B5EF4-FFF2-40B4-BE49-F238E27FC236}">
                  <a16:creationId xmlns:a16="http://schemas.microsoft.com/office/drawing/2014/main" id="{8EC4BCC2-7F0D-4170-0DF3-C3411D54C469}"/>
                </a:ext>
              </a:extLst>
            </p:cNvPr>
            <p:cNvCxnSpPr>
              <a:cxnSpLocks/>
              <a:stCxn id="20" idx="3"/>
              <a:endCxn id="21" idx="2"/>
            </p:cNvCxnSpPr>
            <p:nvPr/>
          </p:nvCxnSpPr>
          <p:spPr>
            <a:xfrm>
              <a:off x="9756742" y="3770564"/>
              <a:ext cx="663804" cy="3101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24" name="Straight Connector 23">
              <a:extLst>
                <a:ext uri="{FF2B5EF4-FFF2-40B4-BE49-F238E27FC236}">
                  <a16:creationId xmlns:a16="http://schemas.microsoft.com/office/drawing/2014/main" id="{E79BB6C9-551F-840D-42FC-BED0A3AB6BCE}"/>
                </a:ext>
              </a:extLst>
            </p:cNvPr>
            <p:cNvCxnSpPr>
              <a:cxnSpLocks/>
              <a:stCxn id="22" idx="0"/>
            </p:cNvCxnSpPr>
            <p:nvPr/>
          </p:nvCxnSpPr>
          <p:spPr>
            <a:xfrm flipV="1">
              <a:off x="10123602" y="3770564"/>
              <a:ext cx="0" cy="581319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064E1203-9395-8F6E-C136-9390067C3075}"/>
                </a:ext>
              </a:extLst>
            </p:cNvPr>
            <p:cNvSpPr txBox="1"/>
            <p:nvPr/>
          </p:nvSpPr>
          <p:spPr>
            <a:xfrm>
              <a:off x="9232769" y="4840532"/>
              <a:ext cx="1781666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BH12601-1</a:t>
              </a:r>
            </a:p>
            <a:p>
              <a:pPr algn="ctr"/>
              <a:r>
                <a:rPr lang="en-US" sz="1200" dirty="0"/>
                <a:t>DD/ID</a:t>
              </a:r>
            </a:p>
            <a:p>
              <a:pPr algn="ctr"/>
              <a:r>
                <a:rPr lang="en-US" sz="1200" dirty="0"/>
                <a:t>Seizures</a:t>
              </a:r>
            </a:p>
            <a:p>
              <a:pPr algn="ctr"/>
              <a:r>
                <a:rPr lang="en-US" sz="1200" dirty="0"/>
                <a:t>Dysmorphic features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5772712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2</TotalTime>
  <Words>88</Words>
  <Application>Microsoft Office PowerPoint</Application>
  <PresentationFormat>Widescreen</PresentationFormat>
  <Paragraphs>34</Paragraphs>
  <Slides>7</Slides>
  <Notes>7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1" baseType="lpstr">
      <vt:lpstr>Aptos</vt:lpstr>
      <vt:lpstr>Aptos Display</vt:lpstr>
      <vt:lpstr>Arial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PNRI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Cliff Lun</dc:creator>
  <cp:lastModifiedBy>Cliff Lun</cp:lastModifiedBy>
  <cp:revision>11</cp:revision>
  <dcterms:created xsi:type="dcterms:W3CDTF">2025-05-20T17:55:18Z</dcterms:created>
  <dcterms:modified xsi:type="dcterms:W3CDTF">2025-07-11T20:57:40Z</dcterms:modified>
</cp:coreProperties>
</file>